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andrea\poznamky\v&#253;sledky\V&#253;sledky%20flowjo\TMRE_HT29_iHDAC\TMRE_vyhodnotenie%20HT-29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andrea\poznamky\v&#253;sledky\V&#253;sledky%20flowjo\TMRE_HT29_iHDAC\TMRE_vyhodnotenie%20HT-29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andrea\poznamky\v&#253;sledky\V&#253;sledky%20flowjo\TMRE_HT29_iHDAC\TMRE_vyhodnotenie%20HT-29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andrea\poznamky\v&#253;sledky\V&#253;sledky%20flowjo\TMRE_HT29_iHDAC\TMRE_vyhodnotenie%20HT-29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0028182783453"/>
          <c:y val="0.18511859366704675"/>
          <c:w val="0.82997183895276927"/>
          <c:h val="0.75714556123414722"/>
        </c:manualLayout>
      </c:layout>
      <c:barChart>
        <c:barDir val="col"/>
        <c:grouping val="clustered"/>
        <c:varyColors val="0"/>
        <c:ser>
          <c:idx val="0"/>
          <c:order val="0"/>
          <c:tx>
            <c:v>24h</c:v>
          </c:tx>
          <c:spPr>
            <a:solidFill>
              <a:sysClr val="window" lastClr="FFFFFF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D$52:$D$57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1.4829784219603446</c:v>
                  </c:pt>
                  <c:pt idx="2">
                    <c:v>13.599059710141729</c:v>
                  </c:pt>
                  <c:pt idx="3">
                    <c:v>12.015518784749469</c:v>
                  </c:pt>
                  <c:pt idx="4">
                    <c:v>11.575284013794148</c:v>
                  </c:pt>
                  <c:pt idx="5">
                    <c:v>12.564139445262459</c:v>
                  </c:pt>
                </c:numCache>
              </c:numRef>
            </c:plus>
            <c:minus>
              <c:numRef>
                <c:f>'data 2'!$D$52:$D$57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1.4829784219603446</c:v>
                  </c:pt>
                  <c:pt idx="2">
                    <c:v>13.599059710141729</c:v>
                  </c:pt>
                  <c:pt idx="3">
                    <c:v>12.015518784749469</c:v>
                  </c:pt>
                  <c:pt idx="4">
                    <c:v>11.575284013794148</c:v>
                  </c:pt>
                  <c:pt idx="5">
                    <c:v>12.564139445262459</c:v>
                  </c:pt>
                </c:numCache>
              </c:numRef>
            </c:minus>
          </c:errBars>
          <c:cat>
            <c:strRef>
              <c:f>'data 2'!$B$52:$B$57</c:f>
              <c:strCache>
                <c:ptCount val="6"/>
                <c:pt idx="0">
                  <c:v>Ct</c:v>
                </c:pt>
                <c:pt idx="1">
                  <c:v>Saha 1 </c:v>
                </c:pt>
                <c:pt idx="2">
                  <c:v>Saha 2</c:v>
                </c:pt>
                <c:pt idx="3">
                  <c:v>HY-PDT </c:v>
                </c:pt>
                <c:pt idx="4">
                  <c:v>Saha 1 + HY-PDT </c:v>
                </c:pt>
                <c:pt idx="5">
                  <c:v>Saha 2 + HY-PDT </c:v>
                </c:pt>
              </c:strCache>
            </c:strRef>
          </c:cat>
          <c:val>
            <c:numRef>
              <c:f>'data 2'!$C$52:$C$57</c:f>
              <c:numCache>
                <c:formatCode>General</c:formatCode>
                <c:ptCount val="6"/>
                <c:pt idx="0">
                  <c:v>97.947500000000005</c:v>
                </c:pt>
                <c:pt idx="1">
                  <c:v>93.452500000000001</c:v>
                </c:pt>
                <c:pt idx="2">
                  <c:v>52.072499999999998</c:v>
                </c:pt>
                <c:pt idx="3">
                  <c:v>83.132499999999993</c:v>
                </c:pt>
                <c:pt idx="4">
                  <c:v>67.61</c:v>
                </c:pt>
                <c:pt idx="5">
                  <c:v>19.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B2-4FEF-AF04-011A3850EB64}"/>
            </c:ext>
          </c:extLst>
        </c:ser>
        <c:ser>
          <c:idx val="1"/>
          <c:order val="1"/>
          <c:tx>
            <c:v>48h</c:v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F$52:$F$57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1.3738267721951003</c:v>
                  </c:pt>
                  <c:pt idx="2">
                    <c:v>14.848571199501553</c:v>
                  </c:pt>
                  <c:pt idx="3">
                    <c:v>8.2077686777020329</c:v>
                  </c:pt>
                  <c:pt idx="4">
                    <c:v>10.08708869463001</c:v>
                  </c:pt>
                  <c:pt idx="5">
                    <c:v>1.5042024464811892</c:v>
                  </c:pt>
                </c:numCache>
              </c:numRef>
            </c:plus>
            <c:minus>
              <c:numRef>
                <c:f>'data 2'!$F$52:$F$57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1.3738267721951003</c:v>
                  </c:pt>
                  <c:pt idx="2">
                    <c:v>14.848571199501553</c:v>
                  </c:pt>
                  <c:pt idx="3">
                    <c:v>8.2077686777020329</c:v>
                  </c:pt>
                  <c:pt idx="4">
                    <c:v>10.08708869463001</c:v>
                  </c:pt>
                  <c:pt idx="5">
                    <c:v>1.5042024464811892</c:v>
                  </c:pt>
                </c:numCache>
              </c:numRef>
            </c:minus>
          </c:errBars>
          <c:val>
            <c:numRef>
              <c:f>'data 2'!$E$52:$E$57</c:f>
              <c:numCache>
                <c:formatCode>General</c:formatCode>
                <c:ptCount val="6"/>
                <c:pt idx="0">
                  <c:v>97.420000000000016</c:v>
                </c:pt>
                <c:pt idx="1">
                  <c:v>95.829999999999984</c:v>
                </c:pt>
                <c:pt idx="2">
                  <c:v>56.4</c:v>
                </c:pt>
                <c:pt idx="3">
                  <c:v>66.11</c:v>
                </c:pt>
                <c:pt idx="4">
                  <c:v>57.592500000000001</c:v>
                </c:pt>
                <c:pt idx="5">
                  <c:v>11.03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B2-4FEF-AF04-011A3850EB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0199656"/>
        <c:axId val="320200440"/>
      </c:barChart>
      <c:catAx>
        <c:axId val="320199656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320200440"/>
        <c:crosses val="autoZero"/>
        <c:auto val="1"/>
        <c:lblAlgn val="ctr"/>
        <c:lblOffset val="100"/>
        <c:noMultiLvlLbl val="0"/>
      </c:catAx>
      <c:valAx>
        <c:axId val="3202004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50" b="1" i="0" u="none" strike="noStrike" baseline="0" dirty="0">
                    <a:effectLst/>
                  </a:rPr>
                  <a:t>% of TMRE+ cells</a:t>
                </a:r>
              </a:p>
            </c:rich>
          </c:tx>
          <c:layout>
            <c:manualLayout>
              <c:xMode val="edge"/>
              <c:yMode val="edge"/>
              <c:x val="2.2539127824489916E-2"/>
              <c:y val="0.2561052338809643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320199656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7873490813648293"/>
          <c:y val="4.1497150383785104E-2"/>
          <c:w val="0.17586351706036746"/>
          <c:h val="8.3376597349846024E-2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25930863773702"/>
          <c:y val="0.13456803390640304"/>
          <c:w val="0.76074011691754329"/>
          <c:h val="0.76709140200210546"/>
        </c:manualLayout>
      </c:layout>
      <c:barChart>
        <c:barDir val="col"/>
        <c:grouping val="clustered"/>
        <c:varyColors val="0"/>
        <c:ser>
          <c:idx val="0"/>
          <c:order val="0"/>
          <c:tx>
            <c:v>24h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D$59:$D$64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21.443234364246457</c:v>
                  </c:pt>
                  <c:pt idx="2">
                    <c:v>7.983235559596098</c:v>
                  </c:pt>
                  <c:pt idx="3">
                    <c:v>12.015518784749469</c:v>
                  </c:pt>
                  <c:pt idx="4">
                    <c:v>17.486292726971424</c:v>
                  </c:pt>
                  <c:pt idx="5">
                    <c:v>3.8749451609022834</c:v>
                  </c:pt>
                </c:numCache>
              </c:numRef>
            </c:plus>
            <c:minus>
              <c:numRef>
                <c:f>'data 2'!$D$59:$D$64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21.443234364246457</c:v>
                  </c:pt>
                  <c:pt idx="2">
                    <c:v>7.983235559596098</c:v>
                  </c:pt>
                  <c:pt idx="3">
                    <c:v>12.015518784749469</c:v>
                  </c:pt>
                  <c:pt idx="4">
                    <c:v>17.486292726971424</c:v>
                  </c:pt>
                  <c:pt idx="5">
                    <c:v>3.8749451609022834</c:v>
                  </c:pt>
                </c:numCache>
              </c:numRef>
            </c:minus>
          </c:errBars>
          <c:cat>
            <c:strRef>
              <c:f>'data 2'!$B$59:$B$64</c:f>
              <c:strCache>
                <c:ptCount val="6"/>
                <c:pt idx="0">
                  <c:v>Ct</c:v>
                </c:pt>
                <c:pt idx="1">
                  <c:v>Tsa 1 </c:v>
                </c:pt>
                <c:pt idx="2">
                  <c:v>Tsa 2</c:v>
                </c:pt>
                <c:pt idx="3">
                  <c:v>HY-PDT </c:v>
                </c:pt>
                <c:pt idx="4">
                  <c:v>Tsa 1 + HY-PDT </c:v>
                </c:pt>
                <c:pt idx="5">
                  <c:v>Tsa 2 + HY-PDT </c:v>
                </c:pt>
              </c:strCache>
            </c:strRef>
          </c:cat>
          <c:val>
            <c:numRef>
              <c:f>'data 2'!$C$59:$C$64</c:f>
              <c:numCache>
                <c:formatCode>General</c:formatCode>
                <c:ptCount val="6"/>
                <c:pt idx="0">
                  <c:v>97.947500000000005</c:v>
                </c:pt>
                <c:pt idx="1">
                  <c:v>67.585000000000008</c:v>
                </c:pt>
                <c:pt idx="2">
                  <c:v>34.585000000000001</c:v>
                </c:pt>
                <c:pt idx="3">
                  <c:v>83.132499999999993</c:v>
                </c:pt>
                <c:pt idx="4">
                  <c:v>59.774999999999999</c:v>
                </c:pt>
                <c:pt idx="5">
                  <c:v>8.699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6B7-48BB-A69D-ABA912388297}"/>
            </c:ext>
          </c:extLst>
        </c:ser>
        <c:ser>
          <c:idx val="1"/>
          <c:order val="1"/>
          <c:tx>
            <c:v>48h</c:v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F$59:$F$64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20.288455666544284</c:v>
                  </c:pt>
                  <c:pt idx="2">
                    <c:v>9.842926394116752</c:v>
                  </c:pt>
                  <c:pt idx="3">
                    <c:v>8.2077686777020329</c:v>
                  </c:pt>
                  <c:pt idx="4">
                    <c:v>22.836747250867408</c:v>
                  </c:pt>
                  <c:pt idx="5">
                    <c:v>2.4392553508533426</c:v>
                  </c:pt>
                </c:numCache>
              </c:numRef>
            </c:plus>
            <c:minus>
              <c:numRef>
                <c:f>'data 2'!$F$59:$F$64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20.288455666544284</c:v>
                  </c:pt>
                  <c:pt idx="2">
                    <c:v>9.842926394116752</c:v>
                  </c:pt>
                  <c:pt idx="3">
                    <c:v>8.2077686777020329</c:v>
                  </c:pt>
                  <c:pt idx="4">
                    <c:v>22.836747250867408</c:v>
                  </c:pt>
                  <c:pt idx="5">
                    <c:v>2.4392553508533426</c:v>
                  </c:pt>
                </c:numCache>
              </c:numRef>
            </c:minus>
          </c:errBars>
          <c:cat>
            <c:strRef>
              <c:f>'data 2'!$B$59:$B$64</c:f>
              <c:strCache>
                <c:ptCount val="6"/>
                <c:pt idx="0">
                  <c:v>Ct</c:v>
                </c:pt>
                <c:pt idx="1">
                  <c:v>Tsa 1 </c:v>
                </c:pt>
                <c:pt idx="2">
                  <c:v>Tsa 2</c:v>
                </c:pt>
                <c:pt idx="3">
                  <c:v>HY-PDT </c:v>
                </c:pt>
                <c:pt idx="4">
                  <c:v>Tsa 1 + HY-PDT </c:v>
                </c:pt>
                <c:pt idx="5">
                  <c:v>Tsa 2 + HY-PDT </c:v>
                </c:pt>
              </c:strCache>
            </c:strRef>
          </c:cat>
          <c:val>
            <c:numRef>
              <c:f>'data 2'!$E$59:$E$64</c:f>
              <c:numCache>
                <c:formatCode>General</c:formatCode>
                <c:ptCount val="6"/>
                <c:pt idx="0">
                  <c:v>97.420000000000016</c:v>
                </c:pt>
                <c:pt idx="1">
                  <c:v>70.74666666666667</c:v>
                </c:pt>
                <c:pt idx="2">
                  <c:v>56.17</c:v>
                </c:pt>
                <c:pt idx="3">
                  <c:v>66.11</c:v>
                </c:pt>
                <c:pt idx="4">
                  <c:v>34.672499999999999</c:v>
                </c:pt>
                <c:pt idx="5">
                  <c:v>9.564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6B7-48BB-A69D-ABA9123882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0198872"/>
        <c:axId val="320196912"/>
      </c:barChart>
      <c:catAx>
        <c:axId val="32019887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320196912"/>
        <c:crosses val="autoZero"/>
        <c:auto val="1"/>
        <c:lblAlgn val="ctr"/>
        <c:lblOffset val="100"/>
        <c:noMultiLvlLbl val="0"/>
      </c:catAx>
      <c:valAx>
        <c:axId val="32019691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b="1" i="0" u="none" strike="noStrike" baseline="0" dirty="0">
                    <a:effectLst/>
                  </a:rPr>
                  <a:t>% of TMRE+ cells</a:t>
                </a:r>
              </a:p>
            </c:rich>
          </c:tx>
          <c:layout>
            <c:manualLayout>
              <c:xMode val="edge"/>
              <c:yMode val="edge"/>
              <c:x val="3.0304098216848218E-2"/>
              <c:y val="0.2122002943733302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320198872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9817935258092739"/>
          <c:y val="2.7664766922523405E-2"/>
          <c:w val="0.17586351706036746"/>
          <c:h val="8.3376597349846024E-2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64106281883368"/>
          <c:y val="0.2357339931103245"/>
          <c:w val="0.78684121296807541"/>
          <c:h val="0.70998106130545102"/>
        </c:manualLayout>
      </c:layout>
      <c:barChart>
        <c:barDir val="col"/>
        <c:grouping val="clustered"/>
        <c:varyColors val="0"/>
        <c:ser>
          <c:idx val="0"/>
          <c:order val="0"/>
          <c:tx>
            <c:v>24h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D$73:$D$78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0.8312640976248159</c:v>
                  </c:pt>
                  <c:pt idx="2">
                    <c:v>1.3775431027739193</c:v>
                  </c:pt>
                  <c:pt idx="3">
                    <c:v>12.015518784749469</c:v>
                  </c:pt>
                  <c:pt idx="4">
                    <c:v>24.988822001046785</c:v>
                  </c:pt>
                  <c:pt idx="5">
                    <c:v>24.868945494330866</c:v>
                  </c:pt>
                </c:numCache>
              </c:numRef>
            </c:plus>
            <c:minus>
              <c:numRef>
                <c:f>'data 2'!$D$73:$D$78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0.8312640976248159</c:v>
                  </c:pt>
                  <c:pt idx="2">
                    <c:v>1.3775431027739193</c:v>
                  </c:pt>
                  <c:pt idx="3">
                    <c:v>12.015518784749469</c:v>
                  </c:pt>
                  <c:pt idx="4">
                    <c:v>24.988822001046785</c:v>
                  </c:pt>
                  <c:pt idx="5">
                    <c:v>24.868945494330866</c:v>
                  </c:pt>
                </c:numCache>
              </c:numRef>
            </c:minus>
          </c:errBars>
          <c:cat>
            <c:strRef>
              <c:f>'data 2'!$B$73:$B$78</c:f>
              <c:strCache>
                <c:ptCount val="6"/>
                <c:pt idx="0">
                  <c:v>Ct</c:v>
                </c:pt>
                <c:pt idx="1">
                  <c:v>NaPB 1 </c:v>
                </c:pt>
                <c:pt idx="2">
                  <c:v>NaPB 2</c:v>
                </c:pt>
                <c:pt idx="3">
                  <c:v>HY-PDT </c:v>
                </c:pt>
                <c:pt idx="4">
                  <c:v>NaPB 1 + HY-PDT </c:v>
                </c:pt>
                <c:pt idx="5">
                  <c:v>NaPB 2 + HY-PDT </c:v>
                </c:pt>
              </c:strCache>
            </c:strRef>
          </c:cat>
          <c:val>
            <c:numRef>
              <c:f>'data 2'!$C$73:$C$78</c:f>
              <c:numCache>
                <c:formatCode>General</c:formatCode>
                <c:ptCount val="6"/>
                <c:pt idx="0">
                  <c:v>97.947500000000005</c:v>
                </c:pt>
                <c:pt idx="1">
                  <c:v>97.05</c:v>
                </c:pt>
                <c:pt idx="2">
                  <c:v>95.237499999999997</c:v>
                </c:pt>
                <c:pt idx="3">
                  <c:v>83.132499999999993</c:v>
                </c:pt>
                <c:pt idx="4">
                  <c:v>68.347499999999997</c:v>
                </c:pt>
                <c:pt idx="5">
                  <c:v>63.765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92-4BE4-BBE4-0F6AFBA1A9A4}"/>
            </c:ext>
          </c:extLst>
        </c:ser>
        <c:ser>
          <c:idx val="1"/>
          <c:order val="1"/>
          <c:tx>
            <c:v>48h</c:v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F$73:$F$78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2.1223493272000837</c:v>
                  </c:pt>
                  <c:pt idx="2">
                    <c:v>2.3293972754055248</c:v>
                  </c:pt>
                  <c:pt idx="3">
                    <c:v>8.2077686777020329</c:v>
                  </c:pt>
                  <c:pt idx="4">
                    <c:v>15.973121955334852</c:v>
                  </c:pt>
                  <c:pt idx="5">
                    <c:v>18.484424073617582</c:v>
                  </c:pt>
                </c:numCache>
              </c:numRef>
            </c:plus>
            <c:minus>
              <c:numRef>
                <c:f>'data 2'!$F$73:$F$78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2.1223493272000837</c:v>
                  </c:pt>
                  <c:pt idx="2">
                    <c:v>2.3293972754055248</c:v>
                  </c:pt>
                  <c:pt idx="3">
                    <c:v>8.2077686777020329</c:v>
                  </c:pt>
                  <c:pt idx="4">
                    <c:v>15.973121955334852</c:v>
                  </c:pt>
                  <c:pt idx="5">
                    <c:v>18.484424073617582</c:v>
                  </c:pt>
                </c:numCache>
              </c:numRef>
            </c:minus>
          </c:errBars>
          <c:cat>
            <c:strRef>
              <c:f>'data 2'!$B$73:$B$78</c:f>
              <c:strCache>
                <c:ptCount val="6"/>
                <c:pt idx="0">
                  <c:v>Ct</c:v>
                </c:pt>
                <c:pt idx="1">
                  <c:v>NaPB 1 </c:v>
                </c:pt>
                <c:pt idx="2">
                  <c:v>NaPB 2</c:v>
                </c:pt>
                <c:pt idx="3">
                  <c:v>HY-PDT </c:v>
                </c:pt>
                <c:pt idx="4">
                  <c:v>NaPB 1 + HY-PDT </c:v>
                </c:pt>
                <c:pt idx="5">
                  <c:v>NaPB 2 + HY-PDT </c:v>
                </c:pt>
              </c:strCache>
            </c:strRef>
          </c:cat>
          <c:val>
            <c:numRef>
              <c:f>'data 2'!$E$73:$E$78</c:f>
              <c:numCache>
                <c:formatCode>General</c:formatCode>
                <c:ptCount val="6"/>
                <c:pt idx="0">
                  <c:v>97.420000000000016</c:v>
                </c:pt>
                <c:pt idx="1">
                  <c:v>95.644999999999982</c:v>
                </c:pt>
                <c:pt idx="2">
                  <c:v>91.787499999999994</c:v>
                </c:pt>
                <c:pt idx="3">
                  <c:v>66.11</c:v>
                </c:pt>
                <c:pt idx="4">
                  <c:v>33.557499999999997</c:v>
                </c:pt>
                <c:pt idx="5">
                  <c:v>34.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92-4BE4-BBE4-0F6AFBA1A9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0202792"/>
        <c:axId val="320200048"/>
      </c:barChart>
      <c:catAx>
        <c:axId val="32020279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320200048"/>
        <c:crosses val="autoZero"/>
        <c:auto val="1"/>
        <c:lblAlgn val="ctr"/>
        <c:lblOffset val="100"/>
        <c:noMultiLvlLbl val="0"/>
      </c:catAx>
      <c:valAx>
        <c:axId val="32020004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50" b="1" i="0" u="none" strike="noStrike" baseline="0" dirty="0">
                    <a:effectLst/>
                  </a:rPr>
                  <a:t>% of TMRE+ cells</a:t>
                </a:r>
              </a:p>
            </c:rich>
          </c:tx>
          <c:layout>
            <c:manualLayout>
              <c:xMode val="edge"/>
              <c:yMode val="edge"/>
              <c:x val="1.9319252420991355E-2"/>
              <c:y val="0.3441287409197136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320202792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7317935258092737"/>
          <c:y val="3.6886355896697871E-2"/>
          <c:w val="0.27608573448047913"/>
          <c:h val="7.6676918531961027E-2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531701321315169"/>
          <c:y val="0.18995855981494039"/>
          <c:w val="0.80332139021543247"/>
          <c:h val="0.7354923284977567"/>
        </c:manualLayout>
      </c:layout>
      <c:barChart>
        <c:barDir val="col"/>
        <c:grouping val="clustered"/>
        <c:varyColors val="0"/>
        <c:ser>
          <c:idx val="0"/>
          <c:order val="0"/>
          <c:tx>
            <c:v>24h</c:v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D$66:$D$71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1.1368780350884888</c:v>
                  </c:pt>
                  <c:pt idx="2">
                    <c:v>11.224018888080979</c:v>
                  </c:pt>
                  <c:pt idx="3">
                    <c:v>12.015518784749469</c:v>
                  </c:pt>
                  <c:pt idx="4">
                    <c:v>21.361839808405957</c:v>
                  </c:pt>
                  <c:pt idx="5">
                    <c:v>14.785602794610682</c:v>
                  </c:pt>
                </c:numCache>
              </c:numRef>
            </c:plus>
            <c:minus>
              <c:numRef>
                <c:f>'data 2'!$D$66:$D$71</c:f>
                <c:numCache>
                  <c:formatCode>General</c:formatCode>
                  <c:ptCount val="6"/>
                  <c:pt idx="0">
                    <c:v>0.37375348381877099</c:v>
                  </c:pt>
                  <c:pt idx="1">
                    <c:v>1.1368780350884888</c:v>
                  </c:pt>
                  <c:pt idx="2">
                    <c:v>11.224018888080979</c:v>
                  </c:pt>
                  <c:pt idx="3">
                    <c:v>12.015518784749469</c:v>
                  </c:pt>
                  <c:pt idx="4">
                    <c:v>21.361839808405957</c:v>
                  </c:pt>
                  <c:pt idx="5">
                    <c:v>14.785602794610682</c:v>
                  </c:pt>
                </c:numCache>
              </c:numRef>
            </c:minus>
          </c:errBars>
          <c:cat>
            <c:strRef>
              <c:f>'data 2'!$B$66:$B$71</c:f>
              <c:strCache>
                <c:ptCount val="6"/>
                <c:pt idx="0">
                  <c:v>Ct</c:v>
                </c:pt>
                <c:pt idx="1">
                  <c:v>Vpa 1 </c:v>
                </c:pt>
                <c:pt idx="2">
                  <c:v>Vpa 2</c:v>
                </c:pt>
                <c:pt idx="3">
                  <c:v>HY-PDT </c:v>
                </c:pt>
                <c:pt idx="4">
                  <c:v>Vpa 1 + HY-PDT </c:v>
                </c:pt>
                <c:pt idx="5">
                  <c:v>Vpa 2 + HY-PDT </c:v>
                </c:pt>
              </c:strCache>
            </c:strRef>
          </c:cat>
          <c:val>
            <c:numRef>
              <c:f>'data 2'!$C$66:$C$71</c:f>
              <c:numCache>
                <c:formatCode>General</c:formatCode>
                <c:ptCount val="6"/>
                <c:pt idx="0">
                  <c:v>97.947500000000005</c:v>
                </c:pt>
                <c:pt idx="1">
                  <c:v>96.422500000000014</c:v>
                </c:pt>
                <c:pt idx="2">
                  <c:v>86.4</c:v>
                </c:pt>
                <c:pt idx="3">
                  <c:v>83.132499999999993</c:v>
                </c:pt>
                <c:pt idx="4">
                  <c:v>71.580000000000013</c:v>
                </c:pt>
                <c:pt idx="5">
                  <c:v>52.355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E2F-4B2A-A46D-C332E1E91BC0}"/>
            </c:ext>
          </c:extLst>
        </c:ser>
        <c:ser>
          <c:idx val="1"/>
          <c:order val="1"/>
          <c:tx>
            <c:v>48h</c:v>
          </c:tx>
          <c:spPr>
            <a:solidFill>
              <a:schemeClr val="tx1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data 2'!$F$66:$F$71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0.76185628566022623</c:v>
                  </c:pt>
                  <c:pt idx="2">
                    <c:v>14.475116579841456</c:v>
                  </c:pt>
                  <c:pt idx="3">
                    <c:v>8.2077686777020329</c:v>
                  </c:pt>
                  <c:pt idx="4">
                    <c:v>12.042649210202871</c:v>
                  </c:pt>
                  <c:pt idx="5">
                    <c:v>13.879731025251646</c:v>
                  </c:pt>
                </c:numCache>
              </c:numRef>
            </c:plus>
            <c:minus>
              <c:numRef>
                <c:f>'data 2'!$F$66:$F$71</c:f>
                <c:numCache>
                  <c:formatCode>General</c:formatCode>
                  <c:ptCount val="6"/>
                  <c:pt idx="0">
                    <c:v>1.0295306373942119</c:v>
                  </c:pt>
                  <c:pt idx="1">
                    <c:v>0.76185628566022623</c:v>
                  </c:pt>
                  <c:pt idx="2">
                    <c:v>14.475116579841456</c:v>
                  </c:pt>
                  <c:pt idx="3">
                    <c:v>8.2077686777020329</c:v>
                  </c:pt>
                  <c:pt idx="4">
                    <c:v>12.042649210202871</c:v>
                  </c:pt>
                  <c:pt idx="5">
                    <c:v>13.879731025251646</c:v>
                  </c:pt>
                </c:numCache>
              </c:numRef>
            </c:minus>
          </c:errBars>
          <c:cat>
            <c:strRef>
              <c:f>'data 2'!$B$66:$B$71</c:f>
              <c:strCache>
                <c:ptCount val="6"/>
                <c:pt idx="0">
                  <c:v>Ct</c:v>
                </c:pt>
                <c:pt idx="1">
                  <c:v>Vpa 1 </c:v>
                </c:pt>
                <c:pt idx="2">
                  <c:v>Vpa 2</c:v>
                </c:pt>
                <c:pt idx="3">
                  <c:v>HY-PDT </c:v>
                </c:pt>
                <c:pt idx="4">
                  <c:v>Vpa 1 + HY-PDT </c:v>
                </c:pt>
                <c:pt idx="5">
                  <c:v>Vpa 2 + HY-PDT </c:v>
                </c:pt>
              </c:strCache>
            </c:strRef>
          </c:cat>
          <c:val>
            <c:numRef>
              <c:f>'data 2'!$E$66:$E$71</c:f>
              <c:numCache>
                <c:formatCode>General</c:formatCode>
                <c:ptCount val="6"/>
                <c:pt idx="0">
                  <c:v>97.420000000000016</c:v>
                </c:pt>
                <c:pt idx="1">
                  <c:v>96.057500000000005</c:v>
                </c:pt>
                <c:pt idx="2">
                  <c:v>87.8</c:v>
                </c:pt>
                <c:pt idx="3">
                  <c:v>66.11</c:v>
                </c:pt>
                <c:pt idx="4">
                  <c:v>60.84</c:v>
                </c:pt>
                <c:pt idx="5">
                  <c:v>25.45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E2F-4B2A-A46D-C332E1E91BC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0200832"/>
        <c:axId val="320203184"/>
      </c:barChart>
      <c:catAx>
        <c:axId val="320200832"/>
        <c:scaling>
          <c:orientation val="minMax"/>
        </c:scaling>
        <c:delete val="1"/>
        <c:axPos val="b"/>
        <c:numFmt formatCode="General" sourceLinked="0"/>
        <c:majorTickMark val="none"/>
        <c:minorTickMark val="none"/>
        <c:tickLblPos val="nextTo"/>
        <c:crossAx val="320203184"/>
        <c:crosses val="autoZero"/>
        <c:auto val="1"/>
        <c:lblAlgn val="ctr"/>
        <c:lblOffset val="100"/>
        <c:noMultiLvlLbl val="0"/>
      </c:catAx>
      <c:valAx>
        <c:axId val="32020318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000" b="1" i="0" u="none" strike="noStrike" baseline="0" dirty="0">
                    <a:effectLst/>
                  </a:rPr>
                  <a:t>% of TMRE+ cells</a:t>
                </a:r>
              </a:p>
            </c:rich>
          </c:tx>
          <c:layout>
            <c:manualLayout>
              <c:xMode val="edge"/>
              <c:yMode val="edge"/>
              <c:x val="3.5418629438484152E-2"/>
              <c:y val="0.27811817635241665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320200832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17595713035870517"/>
          <c:y val="2.7664766922523405E-2"/>
          <c:w val="0.17586351706036746"/>
          <c:h val="8.3376597349846024E-2"/>
        </c:manualLayout>
      </c:layout>
      <c:overlay val="0"/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8972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68589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9474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3215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46315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8356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2171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4055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235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49125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8240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DE552-6C96-46E7-B8C5-7C74DB388C8A}" type="datetimeFigureOut">
              <a:rPr lang="it-IT" smtClean="0"/>
              <a:t>03/02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58C45A-303C-4A75-87FD-2E3E22C6529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33645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9" name="CasellaDiTesto 31"/>
          <p:cNvSpPr txBox="1">
            <a:spLocks noChangeArrowheads="1"/>
          </p:cNvSpPr>
          <p:nvPr/>
        </p:nvSpPr>
        <p:spPr bwMode="auto">
          <a:xfrm>
            <a:off x="1992313" y="620714"/>
            <a:ext cx="3238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A</a:t>
            </a:r>
          </a:p>
        </p:txBody>
      </p:sp>
      <p:sp>
        <p:nvSpPr>
          <p:cNvPr id="14340" name="CasellaDiTesto 32"/>
          <p:cNvSpPr txBox="1">
            <a:spLocks noChangeArrowheads="1"/>
          </p:cNvSpPr>
          <p:nvPr/>
        </p:nvSpPr>
        <p:spPr bwMode="auto">
          <a:xfrm>
            <a:off x="6156326" y="596900"/>
            <a:ext cx="314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B</a:t>
            </a:r>
          </a:p>
        </p:txBody>
      </p:sp>
      <p:sp>
        <p:nvSpPr>
          <p:cNvPr id="14341" name="CasellaDiTesto 33"/>
          <p:cNvSpPr txBox="1">
            <a:spLocks noChangeArrowheads="1"/>
          </p:cNvSpPr>
          <p:nvPr/>
        </p:nvSpPr>
        <p:spPr bwMode="auto">
          <a:xfrm>
            <a:off x="1946276" y="3352800"/>
            <a:ext cx="3079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C</a:t>
            </a:r>
          </a:p>
        </p:txBody>
      </p:sp>
      <p:sp>
        <p:nvSpPr>
          <p:cNvPr id="14342" name="CasellaDiTesto 34"/>
          <p:cNvSpPr txBox="1">
            <a:spLocks noChangeArrowheads="1"/>
          </p:cNvSpPr>
          <p:nvPr/>
        </p:nvSpPr>
        <p:spPr bwMode="auto">
          <a:xfrm>
            <a:off x="6137275" y="3224214"/>
            <a:ext cx="3302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/>
              <a:t>D</a:t>
            </a:r>
          </a:p>
        </p:txBody>
      </p:sp>
      <p:sp>
        <p:nvSpPr>
          <p:cNvPr id="14343" name="Rettangolo 38"/>
          <p:cNvSpPr>
            <a:spLocks noChangeArrowheads="1"/>
          </p:cNvSpPr>
          <p:nvPr/>
        </p:nvSpPr>
        <p:spPr bwMode="auto">
          <a:xfrm>
            <a:off x="1808163" y="2633663"/>
            <a:ext cx="4191000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/>
              <a:t>Saha (µM)            -               1             2.5             -               1             2.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>
                <a:solidFill>
                  <a:srgbClr val="000000"/>
                </a:solidFill>
              </a:rPr>
              <a:t>HY-PDT (nM)</a:t>
            </a:r>
            <a:r>
              <a:rPr lang="it-IT" altLang="it-IT" sz="800">
                <a:solidFill>
                  <a:srgbClr val="000000"/>
                </a:solidFill>
              </a:rPr>
              <a:t>         </a:t>
            </a:r>
            <a:r>
              <a:rPr lang="it-IT" altLang="it-IT" sz="1100">
                <a:solidFill>
                  <a:srgbClr val="000000"/>
                </a:solidFill>
              </a:rPr>
              <a:t> -               -                -              75            75            75</a:t>
            </a:r>
            <a:endParaRPr lang="it-IT" altLang="it-IT" sz="1100"/>
          </a:p>
        </p:txBody>
      </p:sp>
      <p:sp>
        <p:nvSpPr>
          <p:cNvPr id="14344" name="Rettangolo 39"/>
          <p:cNvSpPr>
            <a:spLocks noChangeArrowheads="1"/>
          </p:cNvSpPr>
          <p:nvPr/>
        </p:nvSpPr>
        <p:spPr bwMode="auto">
          <a:xfrm>
            <a:off x="6256339" y="2622551"/>
            <a:ext cx="3914775" cy="430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/>
              <a:t>Tsa (nM)               -            250        500           -             250         50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>
                <a:solidFill>
                  <a:srgbClr val="000000"/>
                </a:solidFill>
              </a:rPr>
              <a:t>HY-PDT (nM)</a:t>
            </a:r>
            <a:r>
              <a:rPr lang="it-IT" altLang="it-IT" sz="800">
                <a:solidFill>
                  <a:srgbClr val="000000"/>
                </a:solidFill>
              </a:rPr>
              <a:t> </a:t>
            </a:r>
            <a:r>
              <a:rPr lang="it-IT" altLang="it-IT" sz="1100">
                <a:solidFill>
                  <a:srgbClr val="000000"/>
                </a:solidFill>
              </a:rPr>
              <a:t>     </a:t>
            </a:r>
            <a:r>
              <a:rPr lang="it-IT" altLang="it-IT" sz="800">
                <a:solidFill>
                  <a:srgbClr val="000000"/>
                </a:solidFill>
              </a:rPr>
              <a:t> </a:t>
            </a:r>
            <a:r>
              <a:rPr lang="it-IT" altLang="it-IT" sz="1100">
                <a:solidFill>
                  <a:srgbClr val="000000"/>
                </a:solidFill>
              </a:rPr>
              <a:t> -               -             -             75            75           75</a:t>
            </a:r>
            <a:endParaRPr lang="it-IT" altLang="it-IT" sz="1100"/>
          </a:p>
        </p:txBody>
      </p:sp>
      <p:sp>
        <p:nvSpPr>
          <p:cNvPr id="14345" name="Rettangolo 40"/>
          <p:cNvSpPr>
            <a:spLocks noChangeArrowheads="1"/>
          </p:cNvSpPr>
          <p:nvPr/>
        </p:nvSpPr>
        <p:spPr bwMode="auto">
          <a:xfrm>
            <a:off x="1833564" y="5516563"/>
            <a:ext cx="4033837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/>
              <a:t>Vpa (µM)              -            500         1000           -             500         100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>
                <a:solidFill>
                  <a:srgbClr val="000000"/>
                </a:solidFill>
              </a:rPr>
              <a:t>HY-PDT (nM)</a:t>
            </a:r>
            <a:r>
              <a:rPr lang="it-IT" altLang="it-IT" sz="800">
                <a:solidFill>
                  <a:srgbClr val="000000"/>
                </a:solidFill>
              </a:rPr>
              <a:t>     </a:t>
            </a:r>
            <a:r>
              <a:rPr lang="it-IT" altLang="it-IT" sz="600">
                <a:solidFill>
                  <a:srgbClr val="000000"/>
                </a:solidFill>
              </a:rPr>
              <a:t>    </a:t>
            </a:r>
            <a:r>
              <a:rPr lang="it-IT" altLang="it-IT" sz="800">
                <a:solidFill>
                  <a:srgbClr val="000000"/>
                </a:solidFill>
              </a:rPr>
              <a:t> </a:t>
            </a:r>
            <a:r>
              <a:rPr lang="it-IT" altLang="it-IT" sz="1100">
                <a:solidFill>
                  <a:srgbClr val="000000"/>
                </a:solidFill>
              </a:rPr>
              <a:t> -               -                -             75            75             75</a:t>
            </a:r>
            <a:endParaRPr lang="it-IT" altLang="it-IT" sz="1100"/>
          </a:p>
        </p:txBody>
      </p:sp>
      <p:sp>
        <p:nvSpPr>
          <p:cNvPr id="14346" name="Rettangolo 41"/>
          <p:cNvSpPr>
            <a:spLocks noChangeArrowheads="1"/>
          </p:cNvSpPr>
          <p:nvPr/>
        </p:nvSpPr>
        <p:spPr bwMode="auto">
          <a:xfrm>
            <a:off x="6313489" y="5516563"/>
            <a:ext cx="3913187" cy="431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/>
              <a:t>NaPB (µM)           -            500        1000          -            500       1000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>
                <a:solidFill>
                  <a:srgbClr val="000000"/>
                </a:solidFill>
              </a:rPr>
              <a:t>HY-PDT (nM)       -               -               -            75            75          75</a:t>
            </a:r>
            <a:endParaRPr lang="it-IT" altLang="it-IT" sz="1100"/>
          </a:p>
        </p:txBody>
      </p:sp>
      <p:grpSp>
        <p:nvGrpSpPr>
          <p:cNvPr id="14347" name="Gruppo 27"/>
          <p:cNvGrpSpPr>
            <a:grpSpLocks/>
          </p:cNvGrpSpPr>
          <p:nvPr/>
        </p:nvGrpSpPr>
        <p:grpSpPr bwMode="auto">
          <a:xfrm>
            <a:off x="1992314" y="747714"/>
            <a:ext cx="3887787" cy="2001837"/>
            <a:chOff x="467544" y="620688"/>
            <a:chExt cx="3957709" cy="2290289"/>
          </a:xfrm>
        </p:grpSpPr>
        <p:graphicFrame>
          <p:nvGraphicFramePr>
            <p:cNvPr id="2" name="Graf 3"/>
            <p:cNvGraphicFramePr>
              <a:graphicFrameLocks/>
            </p:cNvGraphicFramePr>
            <p:nvPr/>
          </p:nvGraphicFramePr>
          <p:xfrm>
            <a:off x="467544" y="620688"/>
            <a:ext cx="3944252" cy="22902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4378" name="CasellaDiTesto 1"/>
            <p:cNvSpPr txBox="1">
              <a:spLocks noChangeArrowheads="1"/>
            </p:cNvSpPr>
            <p:nvPr/>
          </p:nvSpPr>
          <p:spPr bwMode="auto">
            <a:xfrm>
              <a:off x="2226909" y="1481962"/>
              <a:ext cx="371103" cy="5760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it-IT" sz="1400">
                  <a:latin typeface="Arial" charset="0"/>
                </a:rPr>
                <a:t>***</a:t>
              </a:r>
              <a:endParaRPr lang="it-IT" altLang="it-IT" sz="1400"/>
            </a:p>
          </p:txBody>
        </p:sp>
        <p:sp>
          <p:nvSpPr>
            <p:cNvPr id="14379" name="CasellaDiTesto 1"/>
            <p:cNvSpPr txBox="1">
              <a:spLocks noChangeArrowheads="1"/>
            </p:cNvSpPr>
            <p:nvPr/>
          </p:nvSpPr>
          <p:spPr bwMode="auto">
            <a:xfrm>
              <a:off x="2412460" y="1367073"/>
              <a:ext cx="371103" cy="5760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it-IT" sz="1400">
                  <a:latin typeface="Arial" charset="0"/>
                </a:rPr>
                <a:t>***</a:t>
              </a:r>
              <a:endParaRPr lang="it-IT" altLang="it-IT" sz="1400"/>
            </a:p>
          </p:txBody>
        </p:sp>
        <p:sp>
          <p:nvSpPr>
            <p:cNvPr id="14380" name="CasellaDiTesto 1"/>
            <p:cNvSpPr txBox="1">
              <a:spLocks noChangeArrowheads="1"/>
            </p:cNvSpPr>
            <p:nvPr/>
          </p:nvSpPr>
          <p:spPr bwMode="auto">
            <a:xfrm>
              <a:off x="2954952" y="1367073"/>
              <a:ext cx="371103" cy="5760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it-IT" sz="1400">
                  <a:latin typeface="Arial" charset="0"/>
                </a:rPr>
                <a:t>*</a:t>
              </a:r>
              <a:endParaRPr lang="it-IT" altLang="it-IT" sz="1400"/>
            </a:p>
          </p:txBody>
        </p:sp>
        <p:sp>
          <p:nvSpPr>
            <p:cNvPr id="14381" name="CasellaDiTesto 1"/>
            <p:cNvSpPr txBox="1">
              <a:spLocks noChangeArrowheads="1"/>
            </p:cNvSpPr>
            <p:nvPr/>
          </p:nvSpPr>
          <p:spPr bwMode="auto">
            <a:xfrm>
              <a:off x="4054150" y="1793980"/>
              <a:ext cx="371103" cy="5760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it-IT" sz="600">
                  <a:latin typeface="Arial" charset="0"/>
                </a:rPr>
                <a:t> ▲▲▲</a:t>
              </a:r>
              <a:r>
                <a:rPr lang="en-GB" altLang="it-IT" sz="800">
                  <a:latin typeface="Arial" charset="0"/>
                </a:rPr>
                <a:t> </a:t>
              </a:r>
            </a:p>
            <a:p>
              <a:pPr algn="ctr" eaLnBrk="1" hangingPunct="1"/>
              <a:r>
                <a:rPr lang="en-GB" altLang="it-IT" sz="800">
                  <a:latin typeface="Arial" charset="0"/>
                </a:rPr>
                <a:t> ǂǂǂ</a:t>
              </a:r>
              <a:r>
                <a:rPr lang="en-GB" altLang="it-IT" sz="800"/>
                <a:t> </a:t>
              </a:r>
            </a:p>
            <a:p>
              <a:pPr algn="ctr" eaLnBrk="1" hangingPunct="1"/>
              <a:r>
                <a:rPr lang="en-GB" altLang="it-IT" sz="1400">
                  <a:latin typeface="Arial" charset="0"/>
                </a:rPr>
                <a:t>***</a:t>
              </a:r>
              <a:endParaRPr lang="it-IT" altLang="it-IT" sz="1400"/>
            </a:p>
          </p:txBody>
        </p:sp>
        <p:sp>
          <p:nvSpPr>
            <p:cNvPr id="14382" name="CasellaDiTesto 1"/>
            <p:cNvSpPr txBox="1">
              <a:spLocks noChangeArrowheads="1"/>
            </p:cNvSpPr>
            <p:nvPr/>
          </p:nvSpPr>
          <p:spPr bwMode="auto">
            <a:xfrm>
              <a:off x="3805100" y="1505947"/>
              <a:ext cx="371103" cy="5760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it-IT" sz="600">
                  <a:latin typeface="Arial" charset="0"/>
                </a:rPr>
                <a:t>▲▲▲</a:t>
              </a:r>
              <a:r>
                <a:rPr lang="en-GB" altLang="it-IT" sz="800">
                  <a:latin typeface="Arial" charset="0"/>
                </a:rPr>
                <a:t> </a:t>
              </a:r>
            </a:p>
            <a:p>
              <a:pPr algn="ctr" eaLnBrk="1" hangingPunct="1"/>
              <a:r>
                <a:rPr lang="en-GB" altLang="it-IT" sz="800">
                  <a:latin typeface="Arial" charset="0"/>
                </a:rPr>
                <a:t>ǂǂǂ</a:t>
              </a:r>
              <a:r>
                <a:rPr lang="en-GB" altLang="it-IT" sz="800"/>
                <a:t> </a:t>
              </a:r>
            </a:p>
            <a:p>
              <a:pPr algn="ctr" eaLnBrk="1" hangingPunct="1"/>
              <a:r>
                <a:rPr lang="en-GB" altLang="it-IT" sz="1400">
                  <a:latin typeface="Arial" charset="0"/>
                </a:rPr>
                <a:t>***</a:t>
              </a:r>
              <a:endParaRPr lang="it-IT" altLang="it-IT" sz="1400"/>
            </a:p>
          </p:txBody>
        </p:sp>
        <p:sp>
          <p:nvSpPr>
            <p:cNvPr id="14383" name="CasellaDiTesto 1"/>
            <p:cNvSpPr txBox="1">
              <a:spLocks noChangeArrowheads="1"/>
            </p:cNvSpPr>
            <p:nvPr/>
          </p:nvSpPr>
          <p:spPr bwMode="auto">
            <a:xfrm>
              <a:off x="3482635" y="1367073"/>
              <a:ext cx="371103" cy="5760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it-IT" sz="600">
                  <a:latin typeface="Arial" charset="0"/>
                </a:rPr>
                <a:t>▲▲▲</a:t>
              </a:r>
              <a:r>
                <a:rPr lang="en-GB" altLang="it-IT" sz="700">
                  <a:latin typeface="Arial" charset="0"/>
                </a:rPr>
                <a:t> </a:t>
              </a:r>
            </a:p>
            <a:p>
              <a:pPr algn="ctr" eaLnBrk="1" hangingPunct="1"/>
              <a:r>
                <a:rPr lang="en-GB" altLang="it-IT" sz="1400">
                  <a:latin typeface="Arial" charset="0"/>
                </a:rPr>
                <a:t>***</a:t>
              </a:r>
              <a:endParaRPr lang="it-IT" altLang="it-IT" sz="1400"/>
            </a:p>
          </p:txBody>
        </p:sp>
        <p:sp>
          <p:nvSpPr>
            <p:cNvPr id="14384" name="CasellaDiTesto 1"/>
            <p:cNvSpPr txBox="1">
              <a:spLocks noChangeArrowheads="1"/>
            </p:cNvSpPr>
            <p:nvPr/>
          </p:nvSpPr>
          <p:spPr bwMode="auto">
            <a:xfrm>
              <a:off x="3296733" y="1104870"/>
              <a:ext cx="371103" cy="57606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>
              <a:lvl1pPr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itchFamily="34" charset="0"/>
                  <a:cs typeface="Arial" charset="0"/>
                </a:defRPr>
              </a:lvl9pPr>
            </a:lstStyle>
            <a:p>
              <a:pPr algn="ctr" eaLnBrk="1" hangingPunct="1"/>
              <a:r>
                <a:rPr lang="en-GB" altLang="it-IT" sz="600">
                  <a:latin typeface="Arial" charset="0"/>
                </a:rPr>
                <a:t>▲▲</a:t>
              </a:r>
            </a:p>
            <a:p>
              <a:pPr algn="ctr" eaLnBrk="1" hangingPunct="1"/>
              <a:r>
                <a:rPr lang="en-GB" altLang="it-IT" sz="1400">
                  <a:latin typeface="Arial" charset="0"/>
                </a:rPr>
                <a:t>*</a:t>
              </a:r>
              <a:endParaRPr lang="it-IT" altLang="it-IT" sz="1400"/>
            </a:p>
          </p:txBody>
        </p:sp>
      </p:grpSp>
      <p:grpSp>
        <p:nvGrpSpPr>
          <p:cNvPr id="14348" name="Gruppo 57"/>
          <p:cNvGrpSpPr>
            <a:grpSpLocks/>
          </p:cNvGrpSpPr>
          <p:nvPr/>
        </p:nvGrpSpPr>
        <p:grpSpPr bwMode="auto">
          <a:xfrm>
            <a:off x="6413500" y="779463"/>
            <a:ext cx="3943350" cy="2032000"/>
            <a:chOff x="4888902" y="779230"/>
            <a:chExt cx="3944252" cy="2031791"/>
          </a:xfrm>
        </p:grpSpPr>
        <p:grpSp>
          <p:nvGrpSpPr>
            <p:cNvPr id="14366" name="Gruppo 29"/>
            <p:cNvGrpSpPr>
              <a:grpSpLocks/>
            </p:cNvGrpSpPr>
            <p:nvPr/>
          </p:nvGrpSpPr>
          <p:grpSpPr bwMode="auto">
            <a:xfrm>
              <a:off x="4888902" y="779230"/>
              <a:ext cx="3944252" cy="2031791"/>
              <a:chOff x="4932040" y="692696"/>
              <a:chExt cx="3944252" cy="2290289"/>
            </a:xfrm>
          </p:grpSpPr>
          <p:graphicFrame>
            <p:nvGraphicFramePr>
              <p:cNvPr id="3" name="Graf 3"/>
              <p:cNvGraphicFramePr>
                <a:graphicFrameLocks/>
              </p:cNvGraphicFramePr>
              <p:nvPr/>
            </p:nvGraphicFramePr>
            <p:xfrm>
              <a:off x="4932040" y="692696"/>
              <a:ext cx="3944252" cy="22902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pSp>
            <p:nvGrpSpPr>
              <p:cNvPr id="14369" name="Gruppo 28"/>
              <p:cNvGrpSpPr>
                <a:grpSpLocks/>
              </p:cNvGrpSpPr>
              <p:nvPr/>
            </p:nvGrpSpPr>
            <p:grpSpPr bwMode="auto">
              <a:xfrm>
                <a:off x="6588223" y="1180911"/>
                <a:ext cx="2059380" cy="1312078"/>
                <a:chOff x="6588223" y="1180911"/>
                <a:chExt cx="2059380" cy="1312078"/>
              </a:xfrm>
            </p:grpSpPr>
            <p:sp>
              <p:nvSpPr>
                <p:cNvPr id="14370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6588223" y="1594446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*</a:t>
                  </a:r>
                  <a:endParaRPr lang="it-IT" altLang="it-IT" sz="1400"/>
                </a:p>
              </p:txBody>
            </p:sp>
            <p:sp>
              <p:nvSpPr>
                <p:cNvPr id="14371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6738913" y="1335709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</a:t>
                  </a:r>
                  <a:endParaRPr lang="it-IT" altLang="it-IT" sz="1400"/>
                </a:p>
              </p:txBody>
            </p:sp>
            <p:sp>
              <p:nvSpPr>
                <p:cNvPr id="14372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8276500" y="1756975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600">
                      <a:latin typeface="Arial" charset="0"/>
                    </a:rPr>
                    <a:t>▲▲</a:t>
                  </a:r>
                  <a:r>
                    <a:rPr lang="en-GB" altLang="it-IT" sz="800">
                      <a:latin typeface="Arial" charset="0"/>
                    </a:rPr>
                    <a:t> </a:t>
                  </a:r>
                </a:p>
                <a:p>
                  <a:pPr algn="ctr" eaLnBrk="1" hangingPunct="1"/>
                  <a:r>
                    <a:rPr lang="en-GB" altLang="it-IT" sz="800">
                      <a:latin typeface="Arial" charset="0"/>
                    </a:rPr>
                    <a:t>ǂǂǂ</a:t>
                  </a:r>
                  <a:r>
                    <a:rPr lang="en-GB" altLang="it-IT" sz="800"/>
                    <a:t> </a:t>
                  </a:r>
                </a:p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*</a:t>
                  </a:r>
                  <a:endParaRPr lang="it-IT" altLang="it-IT" sz="1400"/>
                </a:p>
              </p:txBody>
            </p:sp>
            <p:sp>
              <p:nvSpPr>
                <p:cNvPr id="14373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8028384" y="1916925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800">
                      <a:latin typeface="Arial" charset="0"/>
                    </a:rPr>
                    <a:t>ǂǂǂ </a:t>
                  </a:r>
                </a:p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*</a:t>
                  </a:r>
                  <a:endParaRPr lang="it-IT" altLang="it-IT" sz="1400"/>
                </a:p>
              </p:txBody>
            </p:sp>
            <p:sp>
              <p:nvSpPr>
                <p:cNvPr id="14374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7255718" y="1229949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</a:t>
                  </a:r>
                  <a:endParaRPr lang="it-IT" altLang="it-IT" sz="1400"/>
                </a:p>
              </p:txBody>
            </p:sp>
            <p:sp>
              <p:nvSpPr>
                <p:cNvPr id="14375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7590249" y="1180911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</a:t>
                  </a:r>
                  <a:endParaRPr lang="it-IT" altLang="it-IT" sz="1400"/>
                </a:p>
              </p:txBody>
            </p:sp>
            <p:sp>
              <p:nvSpPr>
                <p:cNvPr id="14376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7768786" y="1305215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600">
                      <a:latin typeface="Arial" charset="0"/>
                    </a:rPr>
                    <a:t>▲▲</a:t>
                  </a:r>
                  <a:r>
                    <a:rPr lang="en-GB" altLang="it-IT" sz="800">
                      <a:latin typeface="Arial" charset="0"/>
                    </a:rPr>
                    <a:t> </a:t>
                  </a:r>
                </a:p>
                <a:p>
                  <a:pPr algn="ctr" eaLnBrk="1" hangingPunct="1"/>
                  <a:r>
                    <a:rPr lang="en-GB" altLang="it-IT" sz="800">
                      <a:latin typeface="Arial" charset="0"/>
                    </a:rPr>
                    <a:t>ǂǂ</a:t>
                  </a:r>
                  <a:r>
                    <a:rPr lang="en-GB" altLang="it-IT" sz="800"/>
                    <a:t> </a:t>
                  </a:r>
                </a:p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*</a:t>
                  </a:r>
                  <a:endParaRPr lang="it-IT" altLang="it-IT" sz="1400"/>
                </a:p>
              </p:txBody>
            </p:sp>
          </p:grpSp>
        </p:grpSp>
        <p:cxnSp>
          <p:nvCxnSpPr>
            <p:cNvPr id="47" name="Connettore 1 46"/>
            <p:cNvCxnSpPr/>
            <p:nvPr/>
          </p:nvCxnSpPr>
          <p:spPr>
            <a:xfrm>
              <a:off x="5565332" y="2611017"/>
              <a:ext cx="2967717" cy="0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349" name="Gruppo 56"/>
          <p:cNvGrpSpPr>
            <a:grpSpLocks/>
          </p:cNvGrpSpPr>
          <p:nvPr/>
        </p:nvGrpSpPr>
        <p:grpSpPr bwMode="auto">
          <a:xfrm>
            <a:off x="6442075" y="3721101"/>
            <a:ext cx="3830638" cy="1895475"/>
            <a:chOff x="4918081" y="3721646"/>
            <a:chExt cx="3830383" cy="1895590"/>
          </a:xfrm>
        </p:grpSpPr>
        <p:grpSp>
          <p:nvGrpSpPr>
            <p:cNvPr id="14359" name="Gruppo 37"/>
            <p:cNvGrpSpPr>
              <a:grpSpLocks/>
            </p:cNvGrpSpPr>
            <p:nvPr/>
          </p:nvGrpSpPr>
          <p:grpSpPr bwMode="auto">
            <a:xfrm>
              <a:off x="4918081" y="3721646"/>
              <a:ext cx="3830383" cy="1895590"/>
              <a:chOff x="5004048" y="3212976"/>
              <a:chExt cx="3944252" cy="2290289"/>
            </a:xfrm>
          </p:grpSpPr>
          <p:graphicFrame>
            <p:nvGraphicFramePr>
              <p:cNvPr id="5" name="Graf 3"/>
              <p:cNvGraphicFramePr>
                <a:graphicFrameLocks/>
              </p:cNvGraphicFramePr>
              <p:nvPr/>
            </p:nvGraphicFramePr>
            <p:xfrm>
              <a:off x="5004048" y="3212976"/>
              <a:ext cx="3944252" cy="22902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14362" name="Gruppo 36"/>
              <p:cNvGrpSpPr>
                <a:grpSpLocks/>
              </p:cNvGrpSpPr>
              <p:nvPr/>
            </p:nvGrpSpPr>
            <p:grpSpPr bwMode="auto">
              <a:xfrm>
                <a:off x="7385578" y="3881569"/>
                <a:ext cx="1447576" cy="601558"/>
                <a:chOff x="7385578" y="3881569"/>
                <a:chExt cx="1447576" cy="601558"/>
              </a:xfrm>
            </p:grpSpPr>
            <p:sp>
              <p:nvSpPr>
                <p:cNvPr id="14363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7385578" y="3881569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</a:t>
                  </a:r>
                  <a:endParaRPr lang="it-IT" altLang="it-IT" sz="1400"/>
                </a:p>
              </p:txBody>
            </p:sp>
            <p:sp>
              <p:nvSpPr>
                <p:cNvPr id="14364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7961352" y="3907063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600">
                      <a:latin typeface="Arial" charset="0"/>
                    </a:rPr>
                    <a:t>▲▲▲</a:t>
                  </a:r>
                  <a:r>
                    <a:rPr lang="en-GB" altLang="it-IT" sz="800">
                      <a:latin typeface="Arial" charset="0"/>
                    </a:rPr>
                    <a:t> </a:t>
                  </a:r>
                </a:p>
                <a:p>
                  <a:pPr algn="ctr" eaLnBrk="1" hangingPunct="1"/>
                  <a:r>
                    <a:rPr lang="en-GB" altLang="it-IT" sz="800">
                      <a:latin typeface="Arial" charset="0"/>
                    </a:rPr>
                    <a:t>ǂ</a:t>
                  </a:r>
                  <a:r>
                    <a:rPr lang="en-GB" altLang="it-IT" sz="800"/>
                    <a:t> </a:t>
                  </a:r>
                </a:p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*</a:t>
                  </a:r>
                  <a:endParaRPr lang="it-IT" altLang="it-IT" sz="1400"/>
                </a:p>
              </p:txBody>
            </p:sp>
            <p:sp>
              <p:nvSpPr>
                <p:cNvPr id="14365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8462051" y="3897460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600">
                      <a:latin typeface="Arial" charset="0"/>
                    </a:rPr>
                    <a:t>▲▲▲</a:t>
                  </a:r>
                  <a:r>
                    <a:rPr lang="en-GB" altLang="it-IT" sz="800">
                      <a:latin typeface="Arial" charset="0"/>
                    </a:rPr>
                    <a:t> </a:t>
                  </a:r>
                </a:p>
                <a:p>
                  <a:pPr algn="ctr" eaLnBrk="1" hangingPunct="1"/>
                  <a:r>
                    <a:rPr lang="en-GB" altLang="it-IT" sz="800">
                      <a:latin typeface="Arial" charset="0"/>
                    </a:rPr>
                    <a:t>ǂ</a:t>
                  </a:r>
                  <a:r>
                    <a:rPr lang="en-GB" altLang="it-IT" sz="800"/>
                    <a:t> </a:t>
                  </a:r>
                </a:p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*</a:t>
                  </a:r>
                  <a:endParaRPr lang="it-IT" altLang="it-IT" sz="1400"/>
                </a:p>
              </p:txBody>
            </p:sp>
          </p:grpSp>
        </p:grpSp>
        <p:cxnSp>
          <p:nvCxnSpPr>
            <p:cNvPr id="55" name="Connettore 1 54"/>
            <p:cNvCxnSpPr/>
            <p:nvPr/>
          </p:nvCxnSpPr>
          <p:spPr>
            <a:xfrm>
              <a:off x="5565738" y="5517218"/>
              <a:ext cx="3038273" cy="0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350" name="Gruppo 60"/>
          <p:cNvGrpSpPr>
            <a:grpSpLocks/>
          </p:cNvGrpSpPr>
          <p:nvPr/>
        </p:nvGrpSpPr>
        <p:grpSpPr bwMode="auto">
          <a:xfrm>
            <a:off x="1946276" y="3802064"/>
            <a:ext cx="3921125" cy="1857375"/>
            <a:chOff x="421881" y="3801845"/>
            <a:chExt cx="3920874" cy="1858241"/>
          </a:xfrm>
        </p:grpSpPr>
        <p:grpSp>
          <p:nvGrpSpPr>
            <p:cNvPr id="14352" name="Gruppo 35"/>
            <p:cNvGrpSpPr>
              <a:grpSpLocks/>
            </p:cNvGrpSpPr>
            <p:nvPr/>
          </p:nvGrpSpPr>
          <p:grpSpPr bwMode="auto">
            <a:xfrm>
              <a:off x="421881" y="3801845"/>
              <a:ext cx="3920874" cy="1858241"/>
              <a:chOff x="467544" y="3250325"/>
              <a:chExt cx="3944252" cy="2290289"/>
            </a:xfrm>
          </p:grpSpPr>
          <p:graphicFrame>
            <p:nvGraphicFramePr>
              <p:cNvPr id="4" name="Graf 3"/>
              <p:cNvGraphicFramePr>
                <a:graphicFrameLocks/>
              </p:cNvGraphicFramePr>
              <p:nvPr/>
            </p:nvGraphicFramePr>
            <p:xfrm>
              <a:off x="467544" y="3250325"/>
              <a:ext cx="3944252" cy="22902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pSp>
            <p:nvGrpSpPr>
              <p:cNvPr id="14355" name="Gruppo 30"/>
              <p:cNvGrpSpPr>
                <a:grpSpLocks/>
              </p:cNvGrpSpPr>
              <p:nvPr/>
            </p:nvGrpSpPr>
            <p:grpSpPr bwMode="auto">
              <a:xfrm>
                <a:off x="2957831" y="3860990"/>
                <a:ext cx="1408302" cy="814466"/>
                <a:chOff x="2957831" y="3860990"/>
                <a:chExt cx="1408302" cy="814466"/>
              </a:xfrm>
            </p:grpSpPr>
            <p:sp>
              <p:nvSpPr>
                <p:cNvPr id="14356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2957831" y="3905690"/>
                  <a:ext cx="331390" cy="38740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</a:t>
                  </a:r>
                  <a:endParaRPr lang="it-IT" altLang="it-IT" sz="1400"/>
                </a:p>
              </p:txBody>
            </p:sp>
            <p:sp>
              <p:nvSpPr>
                <p:cNvPr id="14357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3995030" y="4099393"/>
                  <a:ext cx="371103" cy="5760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600">
                      <a:latin typeface="Arial" charset="0"/>
                    </a:rPr>
                    <a:t>▲▲▲</a:t>
                  </a:r>
                  <a:r>
                    <a:rPr lang="en-GB" altLang="it-IT" sz="800">
                      <a:latin typeface="Arial" charset="0"/>
                    </a:rPr>
                    <a:t> </a:t>
                  </a:r>
                </a:p>
                <a:p>
                  <a:pPr algn="ctr" eaLnBrk="1" hangingPunct="1"/>
                  <a:r>
                    <a:rPr lang="en-GB" altLang="it-IT" sz="800">
                      <a:latin typeface="Arial" charset="0"/>
                    </a:rPr>
                    <a:t>ǂǂ</a:t>
                  </a:r>
                  <a:r>
                    <a:rPr lang="en-GB" altLang="it-IT" sz="800"/>
                    <a:t> </a:t>
                  </a:r>
                </a:p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*</a:t>
                  </a:r>
                  <a:endParaRPr lang="it-IT" altLang="it-IT" sz="1400"/>
                </a:p>
              </p:txBody>
            </p:sp>
            <p:sp>
              <p:nvSpPr>
                <p:cNvPr id="14358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3816903" y="3860990"/>
                  <a:ext cx="371103" cy="57606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600">
                      <a:latin typeface="Arial" charset="0"/>
                    </a:rPr>
                    <a:t>▲</a:t>
                  </a:r>
                </a:p>
                <a:p>
                  <a:pPr algn="ctr" eaLnBrk="1" hangingPunct="1"/>
                  <a:r>
                    <a:rPr lang="en-GB" altLang="it-IT" sz="1400">
                      <a:latin typeface="Arial" charset="0"/>
                    </a:rPr>
                    <a:t>**</a:t>
                  </a:r>
                  <a:endParaRPr lang="it-IT" altLang="it-IT" sz="1400"/>
                </a:p>
              </p:txBody>
            </p:sp>
          </p:grpSp>
        </p:grpSp>
        <p:cxnSp>
          <p:nvCxnSpPr>
            <p:cNvPr id="59" name="Connettore 1 58"/>
            <p:cNvCxnSpPr/>
            <p:nvPr/>
          </p:nvCxnSpPr>
          <p:spPr>
            <a:xfrm>
              <a:off x="1129861" y="5517144"/>
              <a:ext cx="3144637" cy="0"/>
            </a:xfrm>
            <a:prstGeom prst="line">
              <a:avLst/>
            </a:prstGeom>
            <a:ln w="635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3" name="Connettore 1 62"/>
          <p:cNvCxnSpPr/>
          <p:nvPr/>
        </p:nvCxnSpPr>
        <p:spPr>
          <a:xfrm>
            <a:off x="2654300" y="2633663"/>
            <a:ext cx="3081338" cy="0"/>
          </a:xfrm>
          <a:prstGeom prst="line">
            <a:avLst/>
          </a:prstGeom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015203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4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2</cp:revision>
  <dcterms:created xsi:type="dcterms:W3CDTF">2017-02-03T09:19:03Z</dcterms:created>
  <dcterms:modified xsi:type="dcterms:W3CDTF">2017-02-03T09:20:06Z</dcterms:modified>
</cp:coreProperties>
</file>